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C31B694C-35BC-4F0B-BC8F-CF6F0C5A3EFF}">
  <a:tblStyle styleId="{C31B694C-35BC-4F0B-BC8F-CF6F0C5A3EFF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5346e4f497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15346e4f497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2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https://lh3.googleusercontent.com/pYZkJ44QcMQA82XveB33udkh2FpacjAtxst_FSPVWJbkGWoAK9t0lfdJ2KFQj21QjRe91Pg3SRuehqbjlPPnDpBgCVnotOb2JFJV0VxGSdLOBBoF8tUyJ4Dj29olbuXioBsfWceTwoDWWMLmY3vEJLpOrw" id="60" name="Google Shape;60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084320" y="257839"/>
            <a:ext cx="2834642" cy="2043679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61" name="Google Shape;61;p14"/>
          <p:cNvGraphicFramePr/>
          <p:nvPr/>
        </p:nvGraphicFramePr>
        <p:xfrm>
          <a:off x="4236720" y="230151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31B694C-35BC-4F0B-BC8F-CF6F0C5A3EFF}</a:tableStyleId>
              </a:tblPr>
              <a:tblGrid>
                <a:gridCol w="1417325"/>
                <a:gridCol w="708650"/>
                <a:gridCol w="708650"/>
              </a:tblGrid>
              <a:tr h="165725">
                <a:tc gridSpan="3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FFFFFF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eta diversity results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-valu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²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294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74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7526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06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7620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083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167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293</a:t>
                      </a:r>
                      <a:endParaRPr sz="12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2" name="Google Shape;62;p14"/>
          <p:cNvGraphicFramePr/>
          <p:nvPr/>
        </p:nvGraphicFramePr>
        <p:xfrm>
          <a:off x="242872" y="257839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31B694C-35BC-4F0B-BC8F-CF6F0C5A3EFF}</a:tableStyleId>
              </a:tblPr>
              <a:tblGrid>
                <a:gridCol w="740525"/>
                <a:gridCol w="605750"/>
                <a:gridCol w="763625"/>
                <a:gridCol w="752275"/>
                <a:gridCol w="834550"/>
              </a:tblGrid>
              <a:tr h="229400">
                <a:tc gridSpan="5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fr" sz="1400" u="none" cap="none" strike="noStrike">
                          <a:solidFill>
                            <a:schemeClr val="lt1"/>
                          </a:solidFill>
                        </a:rPr>
                        <a:t>Alpha diversity</a:t>
                      </a:r>
                      <a:endParaRPr b="1" sz="1400" u="none" cap="none" strike="noStrike">
                        <a:solidFill>
                          <a:schemeClr val="lt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  <a:tc hMerge="1"/>
                <a:tc hMerge="1"/>
              </a:tr>
              <a:tr h="333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Test</a:t>
                      </a:r>
                      <a:endParaRPr sz="14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14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Inverse Simpson</a:t>
                      </a:r>
                      <a:endParaRPr sz="14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hannon</a:t>
                      </a:r>
                      <a:endParaRPr sz="14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Observed</a:t>
                      </a:r>
                      <a:endParaRPr sz="14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87700">
                <a:tc rowSpan="2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airwise Wilcoxon rank sum test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2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43792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08550">
                <a:tc rowSpan="8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pearman's rank correlation test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83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535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618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0855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683705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60172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260178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8770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09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9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288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8770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9757927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97286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8675851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33365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6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731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44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33365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7246292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3368538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1978574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8770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577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75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755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333650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170226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464552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97294</a:t>
                      </a:r>
                      <a:endParaRPr sz="12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</a:tbl>
          </a:graphicData>
        </a:graphic>
      </p:graphicFrame>
      <p:sp>
        <p:nvSpPr>
          <p:cNvPr id="63" name="Google Shape;63;p14"/>
          <p:cNvSpPr txBox="1"/>
          <p:nvPr/>
        </p:nvSpPr>
        <p:spPr>
          <a:xfrm>
            <a:off x="28665" y="25525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4" name="Google Shape;64;p14"/>
          <p:cNvSpPr txBox="1"/>
          <p:nvPr/>
        </p:nvSpPr>
        <p:spPr>
          <a:xfrm>
            <a:off x="3986954" y="25525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5" name="Google Shape;65;p14"/>
          <p:cNvSpPr txBox="1"/>
          <p:nvPr/>
        </p:nvSpPr>
        <p:spPr>
          <a:xfrm>
            <a:off x="3986954" y="230151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6" name="Google Shape;66;p14"/>
          <p:cNvSpPr txBox="1"/>
          <p:nvPr/>
        </p:nvSpPr>
        <p:spPr>
          <a:xfrm>
            <a:off x="2143900" y="3755917"/>
            <a:ext cx="3864900" cy="1047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 fontScale="92500" lnSpcReduction="20000"/>
          </a:bodyPr>
          <a:lstStyle/>
          <a:p>
            <a:pPr indent="-178911" lvl="0" marL="177800" marR="0" rtl="0" algn="just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100000"/>
              <a:buFont typeface="Arial"/>
              <a:buChar char="•"/>
            </a:pP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Statistical analysis result obtained for Antibiotic resistance genes population investigation. [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A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results using Pairwise Wilcoxon rank sum test and Spearman’s rank correlation test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B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measure plot for each indices for control (C) and Parkinson (P) groups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C] </a:t>
            </a:r>
            <a:r>
              <a:rPr lang="fr" sz="11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Beta diversity results obtained using Aitchison distance in univariable PERMANOVA models.</a:t>
            </a:r>
            <a:endParaRPr sz="11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